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4" d="100"/>
          <a:sy n="74" d="100"/>
        </p:scale>
        <p:origin x="124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FAB29-02CC-4DBE-A082-D2B84FF1AAF5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D0155-7CDA-431D-AB17-19C4479759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23071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FAB29-02CC-4DBE-A082-D2B84FF1AAF5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D0155-7CDA-431D-AB17-19C4479759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52702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FAB29-02CC-4DBE-A082-D2B84FF1AAF5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D0155-7CDA-431D-AB17-19C4479759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6083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FAB29-02CC-4DBE-A082-D2B84FF1AAF5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D0155-7CDA-431D-AB17-19C4479759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34520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FAB29-02CC-4DBE-A082-D2B84FF1AAF5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D0155-7CDA-431D-AB17-19C4479759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11627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FAB29-02CC-4DBE-A082-D2B84FF1AAF5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D0155-7CDA-431D-AB17-19C4479759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58204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FAB29-02CC-4DBE-A082-D2B84FF1AAF5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D0155-7CDA-431D-AB17-19C4479759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27386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FAB29-02CC-4DBE-A082-D2B84FF1AAF5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D0155-7CDA-431D-AB17-19C4479759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5087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FAB29-02CC-4DBE-A082-D2B84FF1AAF5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D0155-7CDA-431D-AB17-19C4479759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00109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FAB29-02CC-4DBE-A082-D2B84FF1AAF5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D0155-7CDA-431D-AB17-19C4479759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92013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FAB29-02CC-4DBE-A082-D2B84FF1AAF5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D0155-7CDA-431D-AB17-19C4479759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14298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AFAB29-02CC-4DBE-A082-D2B84FF1AAF5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9D0155-7CDA-431D-AB17-19C4479759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19349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extBox 26">
            <a:extLst>
              <a:ext uri="{FF2B5EF4-FFF2-40B4-BE49-F238E27FC236}">
                <a16:creationId xmlns:a16="http://schemas.microsoft.com/office/drawing/2014/main" xmlns="" id="{10D68668-048A-480F-8815-C0D130FF7C9B}"/>
              </a:ext>
            </a:extLst>
          </p:cNvPr>
          <p:cNvSpPr txBox="1"/>
          <p:nvPr/>
        </p:nvSpPr>
        <p:spPr>
          <a:xfrm>
            <a:off x="921896" y="4206240"/>
            <a:ext cx="347472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00 nM PA21A092 (PA92) treatment for 40 h results in significantly less number (median, CTL = 12, PA92 = 10) of daughter merozoite per mature parasite. 50 parasites with merozoites were counted for each treatment. </a:t>
            </a:r>
          </a:p>
        </p:txBody>
      </p:sp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xmlns="" id="{CFC34001-89D4-45C0-9435-C5B45AF10CA1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62024" y="1463890"/>
            <a:ext cx="2502388" cy="2743200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FAA79BD4-BFA2-4654-83A9-824B49B58FFE}"/>
              </a:ext>
            </a:extLst>
          </p:cNvPr>
          <p:cNvSpPr txBox="1"/>
          <p:nvPr/>
        </p:nvSpPr>
        <p:spPr>
          <a:xfrm>
            <a:off x="2049905" y="1188720"/>
            <a:ext cx="13566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TL v PA9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FAA79BD4-BFA2-4654-83A9-824B49B58FFE}"/>
              </a:ext>
            </a:extLst>
          </p:cNvPr>
          <p:cNvSpPr txBox="1"/>
          <p:nvPr/>
        </p:nvSpPr>
        <p:spPr>
          <a:xfrm>
            <a:off x="5726601" y="1188720"/>
            <a:ext cx="13753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TL v KA09</a:t>
            </a:r>
          </a:p>
        </p:txBody>
      </p:sp>
      <p:pic>
        <p:nvPicPr>
          <p:cNvPr id="6" name="Picture 5" descr="Diagram&#10;&#10;Description automatically generated">
            <a:extLst>
              <a:ext uri="{FF2B5EF4-FFF2-40B4-BE49-F238E27FC236}">
                <a16:creationId xmlns:a16="http://schemas.microsoft.com/office/drawing/2014/main" xmlns="" id="{414B14D6-000B-4B8B-AA0F-20F723A8C4BB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46461" y="1463890"/>
            <a:ext cx="2535629" cy="2743200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921895" y="5608156"/>
            <a:ext cx="7277725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agenta dotted line represents median, black dotted lines represent quartile. Mann-Whitney U two-tailed test, **** implies p&lt;0.0001; ns denotes not significant</a:t>
            </a:r>
          </a:p>
        </p:txBody>
      </p:sp>
      <p:sp>
        <p:nvSpPr>
          <p:cNvPr id="4" name="Rectangle 3"/>
          <p:cNvSpPr/>
          <p:nvPr/>
        </p:nvSpPr>
        <p:spPr>
          <a:xfrm>
            <a:off x="4819338" y="4206240"/>
            <a:ext cx="347472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0 pM KAE609 (KA09) treatment for 40 h results has no effect (median, CTL = 12, KA09 = 12) on the number of daughter merozoites per mature parasite. 54 parasites with merozoites were counted for each treatment. </a:t>
            </a:r>
            <a:endParaRPr lang="en-US" sz="1200" dirty="0"/>
          </a:p>
        </p:txBody>
      </p:sp>
      <p:sp>
        <p:nvSpPr>
          <p:cNvPr id="7" name="TextBox 6"/>
          <p:cNvSpPr txBox="1"/>
          <p:nvPr/>
        </p:nvSpPr>
        <p:spPr>
          <a:xfrm>
            <a:off x="2830631" y="3886200"/>
            <a:ext cx="530915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A92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281691" y="3886200"/>
            <a:ext cx="452368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TL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6528205" y="3886200"/>
            <a:ext cx="530915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KA09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5979265" y="3886200"/>
            <a:ext cx="452368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TL</a:t>
            </a:r>
          </a:p>
        </p:txBody>
      </p:sp>
      <p:sp>
        <p:nvSpPr>
          <p:cNvPr id="9" name="Rectangle 8"/>
          <p:cNvSpPr/>
          <p:nvPr/>
        </p:nvSpPr>
        <p:spPr>
          <a:xfrm>
            <a:off x="921895" y="301267"/>
            <a:ext cx="727772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ea typeface="+mj-ea"/>
                <a:cs typeface="+mj-cs"/>
              </a:rPr>
              <a:t>Additional file 2: Figure </a:t>
            </a:r>
            <a:r>
              <a:rPr kumimoji="0" lang="en-US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ea typeface="+mj-ea"/>
                <a:cs typeface="+mj-cs"/>
              </a:rPr>
              <a:t>S2</a:t>
            </a:r>
            <a:r>
              <a:rPr kumimoji="0" lang="en-US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/>
                <a:ea typeface="+mj-ea"/>
                <a:cs typeface="+mj-cs"/>
              </a:rPr>
              <a:t>: Effect of PA21A092 and KAE609 on daughter merozoite per schizont (mature parasite)</a:t>
            </a:r>
            <a:endParaRPr kumimoji="0" lang="en-US" sz="1600" b="0" i="0" u="none" strike="noStrike" kern="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</a:endParaRPr>
          </a:p>
        </p:txBody>
      </p:sp>
    </p:spTree>
    <p:extLst>
      <p:ext uri="{BB962C8B-B14F-4D97-AF65-F5344CB8AC3E}">
        <p14:creationId xmlns:p14="http://schemas.microsoft.com/office/powerpoint/2010/main" val="38999729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68</TotalTime>
  <Words>144</Words>
  <Application>Microsoft Office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ubayet Elahi</dc:creator>
  <cp:lastModifiedBy>Sindhu Chinnaiyan</cp:lastModifiedBy>
  <cp:revision>16</cp:revision>
  <cp:lastPrinted>2022-04-21T13:06:57Z</cp:lastPrinted>
  <dcterms:created xsi:type="dcterms:W3CDTF">2021-11-11T17:04:03Z</dcterms:created>
  <dcterms:modified xsi:type="dcterms:W3CDTF">2023-02-04T12:54:37Z</dcterms:modified>
</cp:coreProperties>
</file>